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0" autoAdjust="0"/>
    <p:restoredTop sz="94660"/>
  </p:normalViewPr>
  <p:slideViewPr>
    <p:cSldViewPr snapToGrid="0">
      <p:cViewPr varScale="1">
        <p:scale>
          <a:sx n="93" d="100"/>
          <a:sy n="93" d="100"/>
        </p:scale>
        <p:origin x="7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B45247-8D5E-4D8F-A646-0A8F29A0AA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1C4AD5-4DF1-4F33-B6E9-293A628DB2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DE4087-611C-4E7D-8CA1-8CF6C1E04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92BC48-1A66-4627-BE92-FFDEA40C1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2E08BF-C333-4583-AB3B-BF5263765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28421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C6E6B8-54F9-4D44-8AE6-9F4052D825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3C5768-E14D-4536-9C95-31E1598BD6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A76CF1-65EB-4BC7-B14C-4FA6BE93C5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D457FB-42D8-4C53-81D1-60C1F3F58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1A327A-E764-42FA-85EE-EE752D1771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66588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FA3B6EA-F91F-43E5-AD08-461F326EE1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CCE6-B98E-4151-8229-833D0978A2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B6AEF4-2845-4D0F-8B98-E354F7E683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9D0192-9886-4CB5-B819-5E2498725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50A694-B4CB-4DC0-85EC-93386F2AD8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361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64ABBA-FE53-4390-A03F-852F32022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397D7-7C46-42D1-B318-1F7A9549C55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F16A2-558A-4851-8DE0-2C8E3E3EAB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6AFBAF-25BB-4450-8578-78D9B19F7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CE7FD-DF89-4C54-9B1A-51A0CBFF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05736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4101E2-142F-4387-8857-B28955D0CB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E61B96-464D-4758-8603-30F2DF6E1B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5D325-9292-45A5-B749-1CDA71B357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8EC95F-45B2-47E2-9D4B-0F9B686E5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1C13EF-1DCD-4590-BFD1-F2CA23D29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44868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FF0D6-8E44-411F-BAF0-17ED85DEE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393615-80B6-4BC7-8259-1EC1F11538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52425A-25ED-4DE9-B452-1CC190EEA2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BE80E2-867A-443D-B381-750E1D050A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5F2732-835E-438B-BE14-883E54196C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3F42D3-918D-4B58-92AE-2446B8084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6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AEF36-F65B-4705-AC65-3D9EF33269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B1900-B932-444F-908C-F6BC333DFC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84864A-4947-4E7D-BAB7-0CC734498E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428BF8-8F52-4EB9-A0BF-D8D894C2B8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FDF884-CF6F-4DA3-98D6-C8A1890EDA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D7179A-9978-4D4F-BC76-12683A61BA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13D489-90A0-4301-BF7B-542BB3EF0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74F0896-3028-4832-ABB6-CE815A4DA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651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93990D-962B-495F-9DB8-B010C4963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88AAE6-1E47-42D0-A2F3-376A5613C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68BA8A-D849-4C63-B91B-CDEC03B05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C94CFE7-746F-4BB9-9910-C9DB9E6BD5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685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7C30E1-EFDF-4230-8D30-C38AA8C79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E16E4C-BEFC-439C-A9E5-7EB9ABA5D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9C6A95A-816D-43F1-9377-7E3D43335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61622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CCFF5-DFE7-471A-BB64-A918CC265D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4D4E86-3A07-4251-8E30-E91D3D53D0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888283-AAB7-44A9-B7DB-FC7E9F092E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7A7B3C-5754-4964-8145-755BB24C1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EBD557-E3DB-4BF7-BBD3-DAD00C1BB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36E24-8F3C-42B8-9874-E27CE93A0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97441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B2CEA-8968-4023-8A02-2D0D83135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3C50CB7-D7EA-4B37-A9AA-8508520BCB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685AE3-9F81-4684-B6FC-986F382973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DA7818-B2F6-42D1-AA05-7BEB6D731E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5D6ABB-E123-4DFD-A733-3C0CD70F0F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F70B9A-6AB0-4ADC-9123-514F60F3D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88408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EF090C-377A-438F-AF69-35D08C3115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99F5B0-F7E5-4BCB-ABBA-D90D7B5D8F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44F2AB-1092-4068-A6B8-E3B9945A96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B090B2-8FDF-459B-9151-ACDFE29A1F76}" type="datetimeFigureOut">
              <a:rPr lang="en-AU" smtClean="0"/>
              <a:t>29/09/2019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318DE8-174E-40AE-9823-47BECEFD47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B579D3-5E3D-4422-9B90-A3B23A76E8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8FA200-F9DA-46A6-BD0F-2C24D53EC60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6252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0AD965A8-89FD-41E7-9497-F853653B6A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8497180"/>
              </p:ext>
            </p:extLst>
          </p:nvPr>
        </p:nvGraphicFramePr>
        <p:xfrm>
          <a:off x="1272809" y="1261672"/>
          <a:ext cx="9468135" cy="4261955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1890157">
                  <a:extLst>
                    <a:ext uri="{9D8B030D-6E8A-4147-A177-3AD203B41FA5}">
                      <a16:colId xmlns:a16="http://schemas.microsoft.com/office/drawing/2014/main" val="2716081353"/>
                    </a:ext>
                  </a:extLst>
                </a:gridCol>
                <a:gridCol w="6420297">
                  <a:extLst>
                    <a:ext uri="{9D8B030D-6E8A-4147-A177-3AD203B41FA5}">
                      <a16:colId xmlns:a16="http://schemas.microsoft.com/office/drawing/2014/main" val="2456426145"/>
                    </a:ext>
                  </a:extLst>
                </a:gridCol>
                <a:gridCol w="1157681">
                  <a:extLst>
                    <a:ext uri="{9D8B030D-6E8A-4147-A177-3AD203B41FA5}">
                      <a16:colId xmlns:a16="http://schemas.microsoft.com/office/drawing/2014/main" val="1586608038"/>
                    </a:ext>
                  </a:extLst>
                </a:gridCol>
              </a:tblGrid>
              <a:tr h="40428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b="1" dirty="0">
                          <a:solidFill>
                            <a:schemeClr val="tx1"/>
                          </a:solidFill>
                          <a:cs typeface="Arial" panose="020B0604020202020204" pitchFamily="34" charset="0"/>
                        </a:rPr>
                        <a:t>Automated messages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Description 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Weeks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300" dirty="0">
                          <a:solidFill>
                            <a:schemeClr val="bg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-24</a:t>
                      </a:r>
                    </a:p>
                  </a:txBody>
                  <a:tcPr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0304086"/>
                  </a:ext>
                </a:extLst>
              </a:tr>
              <a:tr h="56383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Reminder to respond message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(sent if a response to a self-report of exercise sessions message is not received in 24 hours)</a:t>
                      </a: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One way message.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Reminder to respond.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Variable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30322246"/>
                  </a:ext>
                </a:extLst>
              </a:tr>
              <a:tr h="701961">
                <a:tc>
                  <a:txBody>
                    <a:bodyPr/>
                    <a:lstStyle/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b="1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Response not supported message </a:t>
                      </a:r>
                    </a:p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(sent in response to any message received not using keyword)</a:t>
                      </a:r>
                      <a:endParaRPr lang="en-AU" sz="12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One way message. </a:t>
                      </a:r>
                    </a:p>
                    <a:p>
                      <a:pPr algn="l"/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States response not recognised. Encourages contacting research team if needed. Inappropriate responses are monitored by the research team. Any that require action (</a:t>
                      </a:r>
                      <a:r>
                        <a:rPr lang="en-AU" sz="1200" dirty="0" err="1">
                          <a:latin typeface="+mn-lt"/>
                          <a:cs typeface="Arial" panose="020B0604020202020204" pitchFamily="34" charset="0"/>
                        </a:rPr>
                        <a:t>eg.</a:t>
                      </a: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 safety concern) will be followed up by the research team.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algn="l"/>
                      <a:endParaRPr lang="en-AU" sz="10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02464849"/>
                  </a:ext>
                </a:extLst>
              </a:tr>
              <a:tr h="756755">
                <a:tc>
                  <a:txBody>
                    <a:bodyPr/>
                    <a:lstStyle/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Optout message</a:t>
                      </a:r>
                    </a:p>
                    <a:p>
                      <a:pPr marL="4445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(sent in response to ‘STOP’ message)</a:t>
                      </a: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One way message.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Participants can send STOP at anytime.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States the study coordinator will contact to discuss ceasing SMS intervention.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AU" sz="10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93365332"/>
                  </a:ext>
                </a:extLst>
              </a:tr>
              <a:tr h="756755">
                <a:tc>
                  <a:txBody>
                    <a:bodyPr/>
                    <a:lstStyle/>
                    <a:p>
                      <a:pPr marL="44450" indent="0" algn="l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Wingdings" panose="05000000000000000000" pitchFamily="2" charset="2"/>
                        <a:buNone/>
                      </a:pPr>
                      <a:r>
                        <a:rPr lang="en-AU" sz="1200" b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Special occasion message </a:t>
                      </a:r>
                    </a:p>
                    <a:p>
                      <a:pPr marL="4445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Wingdings" panose="05000000000000000000" pitchFamily="2" charset="2"/>
                        <a:buNone/>
                        <a:tabLst/>
                        <a:defRPr/>
                      </a:pPr>
                      <a:r>
                        <a:rPr lang="en-AU" sz="12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(message triggered by inputted dates)</a:t>
                      </a:r>
                      <a:endParaRPr lang="en-AU" sz="12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21600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dirty="0">
                          <a:latin typeface="+mn-lt"/>
                          <a:cs typeface="Arial" panose="020B0604020202020204" pitchFamily="34" charset="0"/>
                        </a:rPr>
                        <a:t>One way message.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12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Arial" panose="020B0604020202020204" pitchFamily="34" charset="0"/>
                        </a:rPr>
                        <a:t>Sent at user </a:t>
                      </a:r>
                      <a:r>
                        <a:rPr lang="en-AU" sz="1200" b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Arial" panose="020B0604020202020204" pitchFamily="34" charset="0"/>
                        </a:rPr>
                        <a:t>i</a:t>
                      </a:r>
                      <a:r>
                        <a:rPr lang="en-AU" sz="12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/>
                          <a:cs typeface="Arial" panose="020B0604020202020204" pitchFamily="34" charset="0"/>
                        </a:rPr>
                        <a:t>) birthdays, ii) Easter, iii) Christmas, iv) intervention completion. </a:t>
                      </a:r>
                      <a:endParaRPr lang="en-AU" sz="12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AU" sz="1000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29657273"/>
                  </a:ext>
                </a:extLst>
              </a:tr>
            </a:tbl>
          </a:graphicData>
        </a:graphic>
      </p:graphicFrame>
      <p:sp>
        <p:nvSpPr>
          <p:cNvPr id="2" name="Oval 1"/>
          <p:cNvSpPr/>
          <p:nvPr/>
        </p:nvSpPr>
        <p:spPr>
          <a:xfrm>
            <a:off x="1142335" y="2136331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5" name="Oval 4"/>
          <p:cNvSpPr/>
          <p:nvPr/>
        </p:nvSpPr>
        <p:spPr>
          <a:xfrm>
            <a:off x="1139459" y="3135579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6" name="Oval 5"/>
          <p:cNvSpPr/>
          <p:nvPr/>
        </p:nvSpPr>
        <p:spPr>
          <a:xfrm>
            <a:off x="1139459" y="4001477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" name="Oval 7"/>
          <p:cNvSpPr/>
          <p:nvPr/>
        </p:nvSpPr>
        <p:spPr>
          <a:xfrm>
            <a:off x="1139459" y="4742786"/>
            <a:ext cx="266700" cy="26670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2E1666A-E5AA-4123-8402-0A71604F9A81}"/>
              </a:ext>
            </a:extLst>
          </p:cNvPr>
          <p:cNvSpPr txBox="1"/>
          <p:nvPr/>
        </p:nvSpPr>
        <p:spPr>
          <a:xfrm>
            <a:off x="9739676" y="969284"/>
            <a:ext cx="904158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300" b="1" dirty="0">
                <a:cs typeface="Arial" panose="020B0604020202020204" pitchFamily="34" charset="0"/>
              </a:rPr>
              <a:t>Frequency</a:t>
            </a:r>
          </a:p>
        </p:txBody>
      </p:sp>
    </p:spTree>
    <p:extLst>
      <p:ext uri="{BB962C8B-B14F-4D97-AF65-F5344CB8AC3E}">
        <p14:creationId xmlns:p14="http://schemas.microsoft.com/office/powerpoint/2010/main" val="554950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1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Nelligan</dc:creator>
  <cp:lastModifiedBy>Rachel Nelligan</cp:lastModifiedBy>
  <cp:revision>3</cp:revision>
  <dcterms:created xsi:type="dcterms:W3CDTF">2019-04-15T03:34:40Z</dcterms:created>
  <dcterms:modified xsi:type="dcterms:W3CDTF">2019-09-29T02:54:46Z</dcterms:modified>
</cp:coreProperties>
</file>